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92"/>
  </p:normalViewPr>
  <p:slideViewPr>
    <p:cSldViewPr snapToGrid="0" snapToObjects="1">
      <p:cViewPr varScale="1">
        <p:scale>
          <a:sx n="74" d="100"/>
          <a:sy n="74" d="100"/>
        </p:scale>
        <p:origin x="176" y="5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georgia/Desktop/Paper%20/hnRNPA1%20data/HNRNPA1%20vs%20AR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HNRNPA1 vs AR'!$M$4</c:f>
              <c:strCache>
                <c:ptCount val="1"/>
                <c:pt idx="0">
                  <c:v>hnRNPA1 weak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HNRNPA1 vs AR'!$J$5:$K$18</c:f>
              <c:multiLvlStrCache>
                <c:ptCount val="14"/>
                <c:lvl>
                  <c:pt idx="0">
                    <c:v>AR negative (n=1277)</c:v>
                  </c:pt>
                  <c:pt idx="1">
                    <c:v>AR weak (n=1260)</c:v>
                  </c:pt>
                  <c:pt idx="2">
                    <c:v>AR moderate (n=1590)</c:v>
                  </c:pt>
                  <c:pt idx="3">
                    <c:v>AR strong (n=3030)</c:v>
                  </c:pt>
                  <c:pt idx="5">
                    <c:v>AR negative (n=890)</c:v>
                  </c:pt>
                  <c:pt idx="6">
                    <c:v>AR weak (n=645)</c:v>
                  </c:pt>
                  <c:pt idx="7">
                    <c:v>AR moderate (n=656)</c:v>
                  </c:pt>
                  <c:pt idx="8">
                    <c:v>AR strong (n=983)</c:v>
                  </c:pt>
                  <c:pt idx="10">
                    <c:v>AR negative (n=214)</c:v>
                  </c:pt>
                  <c:pt idx="11">
                    <c:v>AR weak (n=410)</c:v>
                  </c:pt>
                  <c:pt idx="12">
                    <c:v>AR moderate (n=660)</c:v>
                  </c:pt>
                  <c:pt idx="13">
                    <c:v>AR strong (n=1509)</c:v>
                  </c:pt>
                </c:lvl>
                <c:lvl>
                  <c:pt idx="0">
                    <c:v>All cancers, p&lt;0.0001</c:v>
                  </c:pt>
                  <c:pt idx="5">
                    <c:v>ERG negative, p&lt;0.0001</c:v>
                  </c:pt>
                  <c:pt idx="10">
                    <c:v>ERG positive, p&lt;0.0001</c:v>
                  </c:pt>
                </c:lvl>
              </c:multiLvlStrCache>
            </c:multiLvlStrRef>
          </c:cat>
          <c:val>
            <c:numRef>
              <c:f>'HNRNPA1 vs AR'!$M$5:$M$18</c:f>
              <c:numCache>
                <c:formatCode>#,#00</c:formatCode>
                <c:ptCount val="14"/>
                <c:pt idx="0">
                  <c:v>39.780736100234925</c:v>
                </c:pt>
                <c:pt idx="1">
                  <c:v>29.206349206349209</c:v>
                </c:pt>
                <c:pt idx="2">
                  <c:v>12.389937106918239</c:v>
                </c:pt>
                <c:pt idx="3">
                  <c:v>5.7425742574257432</c:v>
                </c:pt>
                <c:pt idx="5">
                  <c:v>40.337078651685395</c:v>
                </c:pt>
                <c:pt idx="6">
                  <c:v>36.899224806201552</c:v>
                </c:pt>
                <c:pt idx="7">
                  <c:v>18.597560975609756</c:v>
                </c:pt>
                <c:pt idx="8">
                  <c:v>11.495422177009155</c:v>
                </c:pt>
                <c:pt idx="10">
                  <c:v>35.981308411214954</c:v>
                </c:pt>
                <c:pt idx="11">
                  <c:v>15.853658536585366</c:v>
                </c:pt>
                <c:pt idx="12">
                  <c:v>5.7575757575757578</c:v>
                </c:pt>
                <c:pt idx="13">
                  <c:v>2.385685884691848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B37-5A41-9FAB-94D596646A7E}"/>
            </c:ext>
          </c:extLst>
        </c:ser>
        <c:ser>
          <c:idx val="1"/>
          <c:order val="1"/>
          <c:tx>
            <c:strRef>
              <c:f>'HNRNPA1 vs AR'!$N$4</c:f>
              <c:strCache>
                <c:ptCount val="1"/>
                <c:pt idx="0">
                  <c:v>hnRNPA1 moderate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HNRNPA1 vs AR'!$J$5:$K$18</c:f>
              <c:multiLvlStrCache>
                <c:ptCount val="14"/>
                <c:lvl>
                  <c:pt idx="0">
                    <c:v>AR negative (n=1277)</c:v>
                  </c:pt>
                  <c:pt idx="1">
                    <c:v>AR weak (n=1260)</c:v>
                  </c:pt>
                  <c:pt idx="2">
                    <c:v>AR moderate (n=1590)</c:v>
                  </c:pt>
                  <c:pt idx="3">
                    <c:v>AR strong (n=3030)</c:v>
                  </c:pt>
                  <c:pt idx="5">
                    <c:v>AR negative (n=890)</c:v>
                  </c:pt>
                  <c:pt idx="6">
                    <c:v>AR weak (n=645)</c:v>
                  </c:pt>
                  <c:pt idx="7">
                    <c:v>AR moderate (n=656)</c:v>
                  </c:pt>
                  <c:pt idx="8">
                    <c:v>AR strong (n=983)</c:v>
                  </c:pt>
                  <c:pt idx="10">
                    <c:v>AR negative (n=214)</c:v>
                  </c:pt>
                  <c:pt idx="11">
                    <c:v>AR weak (n=410)</c:v>
                  </c:pt>
                  <c:pt idx="12">
                    <c:v>AR moderate (n=660)</c:v>
                  </c:pt>
                  <c:pt idx="13">
                    <c:v>AR strong (n=1509)</c:v>
                  </c:pt>
                </c:lvl>
                <c:lvl>
                  <c:pt idx="0">
                    <c:v>All cancers, p&lt;0.0001</c:v>
                  </c:pt>
                  <c:pt idx="5">
                    <c:v>ERG negative, p&lt;0.0001</c:v>
                  </c:pt>
                  <c:pt idx="10">
                    <c:v>ERG positive, p&lt;0.0001</c:v>
                  </c:pt>
                </c:lvl>
              </c:multiLvlStrCache>
            </c:multiLvlStrRef>
          </c:cat>
          <c:val>
            <c:numRef>
              <c:f>'HNRNPA1 vs AR'!$N$5:$N$18</c:f>
              <c:numCache>
                <c:formatCode>#,#00</c:formatCode>
                <c:ptCount val="14"/>
                <c:pt idx="0">
                  <c:v>18.872357086922477</c:v>
                </c:pt>
                <c:pt idx="1">
                  <c:v>43.888888888888886</c:v>
                </c:pt>
                <c:pt idx="2">
                  <c:v>50.880503144654085</c:v>
                </c:pt>
                <c:pt idx="3">
                  <c:v>47.062706270627061</c:v>
                </c:pt>
                <c:pt idx="5">
                  <c:v>14.269662921348313</c:v>
                </c:pt>
                <c:pt idx="6">
                  <c:v>39.379844961240309</c:v>
                </c:pt>
                <c:pt idx="7">
                  <c:v>55.487804878048784</c:v>
                </c:pt>
                <c:pt idx="8">
                  <c:v>51.068158697863687</c:v>
                </c:pt>
                <c:pt idx="10">
                  <c:v>36.44859813084112</c:v>
                </c:pt>
                <c:pt idx="11">
                  <c:v>51.951219512195124</c:v>
                </c:pt>
                <c:pt idx="12">
                  <c:v>50.303030303030305</c:v>
                </c:pt>
                <c:pt idx="13">
                  <c:v>46.5208747514910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B37-5A41-9FAB-94D596646A7E}"/>
            </c:ext>
          </c:extLst>
        </c:ser>
        <c:ser>
          <c:idx val="2"/>
          <c:order val="2"/>
          <c:tx>
            <c:strRef>
              <c:f>'HNRNPA1 vs AR'!$O$4</c:f>
              <c:strCache>
                <c:ptCount val="1"/>
                <c:pt idx="0">
                  <c:v>hnRNPA1 strong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multiLvlStrRef>
              <c:f>'HNRNPA1 vs AR'!$J$5:$K$18</c:f>
              <c:multiLvlStrCache>
                <c:ptCount val="14"/>
                <c:lvl>
                  <c:pt idx="0">
                    <c:v>AR negative (n=1277)</c:v>
                  </c:pt>
                  <c:pt idx="1">
                    <c:v>AR weak (n=1260)</c:v>
                  </c:pt>
                  <c:pt idx="2">
                    <c:v>AR moderate (n=1590)</c:v>
                  </c:pt>
                  <c:pt idx="3">
                    <c:v>AR strong (n=3030)</c:v>
                  </c:pt>
                  <c:pt idx="5">
                    <c:v>AR negative (n=890)</c:v>
                  </c:pt>
                  <c:pt idx="6">
                    <c:v>AR weak (n=645)</c:v>
                  </c:pt>
                  <c:pt idx="7">
                    <c:v>AR moderate (n=656)</c:v>
                  </c:pt>
                  <c:pt idx="8">
                    <c:v>AR strong (n=983)</c:v>
                  </c:pt>
                  <c:pt idx="10">
                    <c:v>AR negative (n=214)</c:v>
                  </c:pt>
                  <c:pt idx="11">
                    <c:v>AR weak (n=410)</c:v>
                  </c:pt>
                  <c:pt idx="12">
                    <c:v>AR moderate (n=660)</c:v>
                  </c:pt>
                  <c:pt idx="13">
                    <c:v>AR strong (n=1509)</c:v>
                  </c:pt>
                </c:lvl>
                <c:lvl>
                  <c:pt idx="0">
                    <c:v>All cancers, p&lt;0.0001</c:v>
                  </c:pt>
                  <c:pt idx="5">
                    <c:v>ERG negative, p&lt;0.0001</c:v>
                  </c:pt>
                  <c:pt idx="10">
                    <c:v>ERG positive, p&lt;0.0001</c:v>
                  </c:pt>
                </c:lvl>
              </c:multiLvlStrCache>
            </c:multiLvlStrRef>
          </c:cat>
          <c:val>
            <c:numRef>
              <c:f>'HNRNPA1 vs AR'!$O$5:$O$18</c:f>
              <c:numCache>
                <c:formatCode>#,#00</c:formatCode>
                <c:ptCount val="14"/>
                <c:pt idx="0">
                  <c:v>7.3610023492560686</c:v>
                </c:pt>
                <c:pt idx="1">
                  <c:v>22.063492063492063</c:v>
                </c:pt>
                <c:pt idx="2">
                  <c:v>35.786163522012579</c:v>
                </c:pt>
                <c:pt idx="3">
                  <c:v>46.699669966996701</c:v>
                </c:pt>
                <c:pt idx="5">
                  <c:v>4.8314606741573032</c:v>
                </c:pt>
                <c:pt idx="6">
                  <c:v>15.968992248062017</c:v>
                </c:pt>
                <c:pt idx="7">
                  <c:v>24.390243902439025</c:v>
                </c:pt>
                <c:pt idx="8">
                  <c:v>36.317395727365209</c:v>
                </c:pt>
                <c:pt idx="10">
                  <c:v>16.822429906542055</c:v>
                </c:pt>
                <c:pt idx="11">
                  <c:v>30.975609756097562</c:v>
                </c:pt>
                <c:pt idx="12">
                  <c:v>43.484848484848484</c:v>
                </c:pt>
                <c:pt idx="13">
                  <c:v>51.0271703114645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B37-5A41-9FAB-94D596646A7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0"/>
        <c:overlap val="100"/>
        <c:axId val="1154946352"/>
        <c:axId val="1207567184"/>
      </c:barChart>
      <c:catAx>
        <c:axId val="11549463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1207567184"/>
        <c:crosses val="autoZero"/>
        <c:auto val="1"/>
        <c:lblAlgn val="ctr"/>
        <c:lblOffset val="100"/>
        <c:noMultiLvlLbl val="0"/>
      </c:catAx>
      <c:valAx>
        <c:axId val="1207567184"/>
        <c:scaling>
          <c:orientation val="minMax"/>
          <c:max val="1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/>
                  <a:t>Fraction of tumors (%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de-DE"/>
            </a:p>
          </c:txPr>
        </c:title>
        <c:numFmt formatCode="#,#00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115494635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de-DE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2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32AD0F-3276-8E49-BA4C-7AE46B3D86D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de-D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856D574-91D6-1F4A-B6EE-97C86901C90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55D639C-D5D2-FE40-B8EC-93F854EC8F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4A21F-9BE2-C94E-B608-20691A6FFA36}" type="datetimeFigureOut">
              <a:rPr lang="de-DE" smtClean="0"/>
              <a:t>23.12.19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8800CE-C42D-3445-90C5-6449227CBE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F4A84F-0083-6D45-86FF-EB8E50A426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772264-AAA5-C946-AABF-629737DF148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05215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3F133E-052F-E348-8FAC-984CE4ACBF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de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B0CA3A2-6718-AF4F-813F-D1B3FC3FE0B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EC87FF9-CE36-D145-94F5-56336E26BA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4A21F-9BE2-C94E-B608-20691A6FFA36}" type="datetimeFigureOut">
              <a:rPr lang="de-DE" smtClean="0"/>
              <a:t>23.12.19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AAC1F6-5F40-924C-9C8A-40CD0E99CB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8E54F9B-8A69-EC4B-B718-4E8FF128BE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772264-AAA5-C946-AABF-629737DF148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34649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CBD3474-F865-CF49-B3DC-5527B7F58A0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de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435C5F4-B5FD-A848-88B4-A1936F655CD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99DF44A-6C8D-274D-9772-A2CB35E5E2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4A21F-9BE2-C94E-B608-20691A6FFA36}" type="datetimeFigureOut">
              <a:rPr lang="de-DE" smtClean="0"/>
              <a:t>23.12.19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C67FD0-C501-C047-B4C0-7FDB761866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8176B8-F725-2E4C-A65E-E542EBF316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772264-AAA5-C946-AABF-629737DF148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894427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A2C4F4-0231-2C49-AAB2-7B76E01ECD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de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8E1993B-CB2E-0746-8390-27DD9C29156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FB8BC9-CB65-F54C-B3A7-5C2712E2C4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4A21F-9BE2-C94E-B608-20691A6FFA36}" type="datetimeFigureOut">
              <a:rPr lang="de-DE" smtClean="0"/>
              <a:t>23.12.19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A05798-06BB-164E-A7A1-E553A75809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7B4AD8-A8C8-D247-A5B8-5913B21290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772264-AAA5-C946-AABF-629737DF148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29024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2C8AAE-7A03-FC48-B7C5-48DF3F704F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de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9DCDEC5-137A-7342-BA47-631EE12AFF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F5D1EF-4621-1442-AD4A-12E4B2B519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4A21F-9BE2-C94E-B608-20691A6FFA36}" type="datetimeFigureOut">
              <a:rPr lang="de-DE" smtClean="0"/>
              <a:t>23.12.19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5607D7-475B-2D4C-A808-605FA1625A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C0A147-1882-DA45-A9A9-CBF737FE86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772264-AAA5-C946-AABF-629737DF148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607354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36D4B6-6FF8-CF47-8F7D-05D7418DA2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de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FC0243D-AA1F-6F48-B676-D3389C5AA70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de-D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9C33408-F8F0-E847-9D16-D95BC455C34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de-D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A5EFB55-48F5-B24A-B433-F7438432B1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4A21F-9BE2-C94E-B608-20691A6FFA36}" type="datetimeFigureOut">
              <a:rPr lang="de-DE" smtClean="0"/>
              <a:t>23.12.19</a:t>
            </a:fld>
            <a:endParaRPr lang="de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49AF97A-6EB3-DB41-9874-4C27BF5B50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8276A33-A7E0-9B45-89AD-1E28113E61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772264-AAA5-C946-AABF-629737DF148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220134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AFB285-4724-DF47-8736-110159451C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de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070C404-D93A-F64E-AB4B-71CE42228CA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23BEFBF-753B-034E-9C2D-01479E4CDCE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de-D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A919D01-568A-8749-B774-7FC24E2BC10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E14AA3C-CBBD-1640-8DBF-3C6BA303CF9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de-D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B13A554-98F0-D343-89B9-F384936934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4A21F-9BE2-C94E-B608-20691A6FFA36}" type="datetimeFigureOut">
              <a:rPr lang="de-DE" smtClean="0"/>
              <a:t>23.12.19</a:t>
            </a:fld>
            <a:endParaRPr lang="de-D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7CB8C26-15B3-4A49-B2A9-80A4D3518B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4830396-F50E-6A47-9248-17C0973667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772264-AAA5-C946-AABF-629737DF148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279277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1E72CA-874E-8944-B8ED-4D7DDCFF8C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de-D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5FA7DAA-187C-4143-9154-7E196EB567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4A21F-9BE2-C94E-B608-20691A6FFA36}" type="datetimeFigureOut">
              <a:rPr lang="de-DE" smtClean="0"/>
              <a:t>23.12.19</a:t>
            </a:fld>
            <a:endParaRPr lang="de-D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2B861A6-2F0E-5748-BE84-8B0258D981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2AF0A4F-321B-9F48-B33A-F9FEE75B84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772264-AAA5-C946-AABF-629737DF148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296256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0F3663B-8904-5D46-8713-31FCA84F3B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4A21F-9BE2-C94E-B608-20691A6FFA36}" type="datetimeFigureOut">
              <a:rPr lang="de-DE" smtClean="0"/>
              <a:t>23.12.19</a:t>
            </a:fld>
            <a:endParaRPr lang="de-D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4577A87-0A0C-B84A-9744-DF87E0EA2A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16277E4-794E-B649-8823-EF95F8A0AA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772264-AAA5-C946-AABF-629737DF148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064757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BE66F0-FD24-CF45-BDE6-9E897C608E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de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7E16D5D-49EB-F440-8CDD-2CA26D977FB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de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A4F7FEA-5A86-7C46-A5DD-0EA39AD9D61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B6BB761-A74B-8444-A6EA-DB8F4F6933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4A21F-9BE2-C94E-B608-20691A6FFA36}" type="datetimeFigureOut">
              <a:rPr lang="de-DE" smtClean="0"/>
              <a:t>23.12.19</a:t>
            </a:fld>
            <a:endParaRPr lang="de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5CBB5A0-E665-5D4F-BB0F-D66B8E062E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AC1C9CA-75A0-C247-BF67-95BAE59A9B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772264-AAA5-C946-AABF-629737DF148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208781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906C13-A524-E040-AA30-D540706E75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de-D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F9ECD91-E9A6-894F-BB6B-D4AD5CBFA3E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A2C166D-0F77-D247-A433-B7CC88BFB23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B6394FB-2686-C94C-A499-979F303D13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4A21F-9BE2-C94E-B608-20691A6FFA36}" type="datetimeFigureOut">
              <a:rPr lang="de-DE" smtClean="0"/>
              <a:t>23.12.19</a:t>
            </a:fld>
            <a:endParaRPr lang="de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46303EF-F20F-2F49-A12D-D06C755F44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F4992A1-62D1-2E4D-9BC3-8D1F03F0AA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772264-AAA5-C946-AABF-629737DF148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200572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B8717B6-FA25-CF46-AC9A-413191787A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de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7DB8F53-7E8F-484A-817F-1F4D2AEA561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AF48F28-8ED6-D144-A2BD-F7AD8934603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34A21F-9BE2-C94E-B608-20691A6FFA36}" type="datetimeFigureOut">
              <a:rPr lang="de-DE" smtClean="0"/>
              <a:t>23.12.19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7C3899-E9FF-814A-8BE6-4EAB7654BAB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B500E5-2EAB-E542-A551-4379EC71180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772264-AAA5-C946-AABF-629737DF148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365210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Diagramm 1">
            <a:extLst>
              <a:ext uri="{FF2B5EF4-FFF2-40B4-BE49-F238E27FC236}">
                <a16:creationId xmlns:a16="http://schemas.microsoft.com/office/drawing/2014/main" id="{F3C9E620-958D-5244-8D0D-8ACC59B6D80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08112437"/>
              </p:ext>
            </p:extLst>
          </p:nvPr>
        </p:nvGraphicFramePr>
        <p:xfrm>
          <a:off x="844550" y="1022350"/>
          <a:ext cx="10502900" cy="36703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Rectangle 5">
            <a:extLst>
              <a:ext uri="{FF2B5EF4-FFF2-40B4-BE49-F238E27FC236}">
                <a16:creationId xmlns:a16="http://schemas.microsoft.com/office/drawing/2014/main" id="{62080076-3C98-6C43-BE90-4593ACB852A1}"/>
              </a:ext>
            </a:extLst>
          </p:cNvPr>
          <p:cNvSpPr/>
          <p:nvPr/>
        </p:nvSpPr>
        <p:spPr>
          <a:xfrm>
            <a:off x="1469231" y="4975892"/>
            <a:ext cx="9253537" cy="49904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0"/>
              </a:spcAft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de-DE" sz="12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15000"/>
              </a:lnSpc>
              <a:spcAft>
                <a:spcPts val="0"/>
              </a:spcAft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3: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HnRNPA1 immunostaining and </a:t>
            </a:r>
            <a:r>
              <a:rPr lang="en-US" sz="120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drogen receptor (AR)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xpression.</a:t>
            </a:r>
            <a:endParaRPr lang="de-DE" sz="12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BCED1825-231F-D342-B7DC-018484D80ECC}"/>
              </a:ext>
            </a:extLst>
          </p:cNvPr>
          <p:cNvSpPr/>
          <p:nvPr/>
        </p:nvSpPr>
        <p:spPr>
          <a:xfrm>
            <a:off x="1090613" y="225377"/>
            <a:ext cx="6096000" cy="715773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lnSpc>
                <a:spcPct val="115000"/>
              </a:lnSpc>
              <a:spcAft>
                <a:spcPts val="0"/>
              </a:spcAft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. 3 </a:t>
            </a:r>
            <a:endParaRPr lang="de-DE" sz="12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15000"/>
              </a:lnSpc>
              <a:spcAft>
                <a:spcPts val="0"/>
              </a:spcAft>
            </a:pP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nRNPA1 and androgen receptor (AR) expression</a:t>
            </a:r>
            <a:endParaRPr lang="de-DE" sz="12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15000"/>
              </a:lnSpc>
              <a:spcAft>
                <a:spcPts val="0"/>
              </a:spcAft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de-DE" sz="12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092122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32</Words>
  <Application>Microsoft Macintosh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6</cp:revision>
  <dcterms:created xsi:type="dcterms:W3CDTF">2019-11-29T19:57:21Z</dcterms:created>
  <dcterms:modified xsi:type="dcterms:W3CDTF">2019-12-23T10:45:46Z</dcterms:modified>
</cp:coreProperties>
</file>